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04619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0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0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0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0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0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0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0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0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0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0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0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0/10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67544" y="5448706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avarese et al (2023) Diabetologia DOI 10.1007/s00125-023-06031-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The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Role of MR overactivation in cardiorenal disease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A52F7A1-038F-C79E-336B-5C332445B4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75656" y="980728"/>
            <a:ext cx="6336704" cy="4617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36073" y="5448706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avarese et al (2023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3-06031-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Distinct characteristics and mechanisms of </a:t>
            </a:r>
            <a:r>
              <a:rPr lang="en-US" sz="1800" b="1" dirty="0" err="1"/>
              <a:t>finerenone</a:t>
            </a:r>
            <a:r>
              <a:rPr lang="en-US" sz="1800" b="1" dirty="0"/>
              <a:t> vs classical steroidal MRA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38F6ABF-5661-A99B-E447-B13C17CA122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99792" y="814424"/>
            <a:ext cx="4047552" cy="51348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3779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</Words>
  <Application>Microsoft Office PowerPoint</Application>
  <PresentationFormat>On-screen Show (4:3)</PresentationFormat>
  <Paragraphs>1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4</cp:revision>
  <dcterms:created xsi:type="dcterms:W3CDTF">2016-06-15T12:53:43Z</dcterms:created>
  <dcterms:modified xsi:type="dcterms:W3CDTF">2023-10-20T08:14:25Z</dcterms:modified>
</cp:coreProperties>
</file>